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49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l="12640" r="8994" b="12391"/>
          <a:stretch>
            <a:fillRect/>
          </a:stretch>
        </p:blipFill>
        <p:spPr bwMode="auto">
          <a:xfrm>
            <a:off x="611560" y="360040"/>
            <a:ext cx="2232248" cy="1872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l="12640" b="9021"/>
          <a:stretch>
            <a:fillRect/>
          </a:stretch>
        </p:blipFill>
        <p:spPr bwMode="auto">
          <a:xfrm>
            <a:off x="3203848" y="360040"/>
            <a:ext cx="2488438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 l="12640" b="9021"/>
          <a:stretch>
            <a:fillRect/>
          </a:stretch>
        </p:blipFill>
        <p:spPr bwMode="auto">
          <a:xfrm>
            <a:off x="5868144" y="360040"/>
            <a:ext cx="2488438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 l="12640" b="12391"/>
          <a:stretch>
            <a:fillRect/>
          </a:stretch>
        </p:blipFill>
        <p:spPr bwMode="auto">
          <a:xfrm>
            <a:off x="611560" y="2232248"/>
            <a:ext cx="2488438" cy="1872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 l="12640" b="9021"/>
          <a:stretch>
            <a:fillRect/>
          </a:stretch>
        </p:blipFill>
        <p:spPr bwMode="auto">
          <a:xfrm>
            <a:off x="3203848" y="2232248"/>
            <a:ext cx="2488438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/>
          <a:srcRect l="12640" b="9021"/>
          <a:stretch>
            <a:fillRect/>
          </a:stretch>
        </p:blipFill>
        <p:spPr bwMode="auto">
          <a:xfrm>
            <a:off x="5868144" y="2232248"/>
            <a:ext cx="2488438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/>
          <a:srcRect l="12640" b="8827"/>
          <a:stretch>
            <a:fillRect/>
          </a:stretch>
        </p:blipFill>
        <p:spPr bwMode="auto">
          <a:xfrm>
            <a:off x="611560" y="4176464"/>
            <a:ext cx="2488438" cy="1948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/>
          <a:srcRect l="12640" b="8827"/>
          <a:stretch>
            <a:fillRect/>
          </a:stretch>
        </p:blipFill>
        <p:spPr bwMode="auto">
          <a:xfrm>
            <a:off x="3235690" y="4180604"/>
            <a:ext cx="2488438" cy="1948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0" cstate="print"/>
          <a:srcRect l="12640" b="8827"/>
          <a:stretch>
            <a:fillRect/>
          </a:stretch>
        </p:blipFill>
        <p:spPr bwMode="auto">
          <a:xfrm>
            <a:off x="5868144" y="4248472"/>
            <a:ext cx="2488438" cy="1948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0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1</a:t>
            </a:r>
            <a:endParaRPr lang="en-GB" dirty="0"/>
          </a:p>
        </p:txBody>
      </p:sp>
      <p:sp>
        <p:nvSpPr>
          <p:cNvPr id="13" name="Rectangle 12"/>
          <p:cNvSpPr/>
          <p:nvPr/>
        </p:nvSpPr>
        <p:spPr>
          <a:xfrm>
            <a:off x="395536" y="1872208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395536" y="3744416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762000" y="6353944"/>
            <a:ext cx="7467600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>
                <a:solidFill>
                  <a:schemeClr val="tx1"/>
                </a:solidFill>
              </a:rPr>
              <a:t>Field maps at time 0.105s post stimulus onset over the 9 scanning sessions. 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059832" y="5616624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3059832" y="3888432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2915816" y="1800200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5724128" y="1872208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5652120" y="3744416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5652120" y="5688632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/>
          <p:cNvSpPr txBox="1"/>
          <p:nvPr/>
        </p:nvSpPr>
        <p:spPr>
          <a:xfrm>
            <a:off x="8100392" y="1080120"/>
            <a:ext cx="3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 smtClean="0"/>
              <a:t>fT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203848" y="0"/>
            <a:ext cx="2247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essions 1-9, t=0.105s</a:t>
            </a:r>
            <a:endParaRPr lang="en-GB" dirty="0"/>
          </a:p>
        </p:txBody>
      </p:sp>
      <p:sp>
        <p:nvSpPr>
          <p:cNvPr id="25" name="Rectangle 24"/>
          <p:cNvSpPr/>
          <p:nvPr/>
        </p:nvSpPr>
        <p:spPr>
          <a:xfrm>
            <a:off x="381000" y="5715000"/>
            <a:ext cx="381000" cy="533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 l="13898" t="33428" r="22386" b="34580"/>
          <a:stretch>
            <a:fillRect/>
          </a:stretch>
        </p:blipFill>
        <p:spPr bwMode="auto">
          <a:xfrm>
            <a:off x="5706738" y="4653136"/>
            <a:ext cx="1673574" cy="12121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 l="15156" t="32942" r="20774" b="33727"/>
          <a:stretch>
            <a:fillRect/>
          </a:stretch>
        </p:blipFill>
        <p:spPr bwMode="auto">
          <a:xfrm>
            <a:off x="3393195" y="4653136"/>
            <a:ext cx="1682861" cy="1262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 l="15995" t="33378" r="21096" b="34454"/>
          <a:stretch>
            <a:fillRect/>
          </a:stretch>
        </p:blipFill>
        <p:spPr bwMode="auto">
          <a:xfrm>
            <a:off x="903383" y="4653136"/>
            <a:ext cx="1652393" cy="12188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 l="14737" t="32835" r="19644" b="34745"/>
          <a:stretch>
            <a:fillRect/>
          </a:stretch>
        </p:blipFill>
        <p:spPr bwMode="auto">
          <a:xfrm>
            <a:off x="5728771" y="2852936"/>
            <a:ext cx="1723549" cy="12284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/>
          <a:srcRect l="15156" t="32544" r="21838" b="33873"/>
          <a:stretch>
            <a:fillRect/>
          </a:stretch>
        </p:blipFill>
        <p:spPr bwMode="auto">
          <a:xfrm>
            <a:off x="3349128" y="2852936"/>
            <a:ext cx="1654920" cy="12724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/>
          <a:srcRect l="15995" t="33552" r="20257" b="34141"/>
          <a:stretch>
            <a:fillRect/>
          </a:stretch>
        </p:blipFill>
        <p:spPr bwMode="auto">
          <a:xfrm>
            <a:off x="971600" y="2852936"/>
            <a:ext cx="1674426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/>
          <a:srcRect l="14317" t="33901" r="21127" b="33792"/>
          <a:stretch>
            <a:fillRect/>
          </a:stretch>
        </p:blipFill>
        <p:spPr bwMode="auto">
          <a:xfrm>
            <a:off x="5684704" y="1124744"/>
            <a:ext cx="1695608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9" cstate="print"/>
          <a:srcRect l="15576" t="33589" r="21612" b="33873"/>
          <a:stretch>
            <a:fillRect/>
          </a:stretch>
        </p:blipFill>
        <p:spPr bwMode="auto">
          <a:xfrm>
            <a:off x="3426245" y="1124744"/>
            <a:ext cx="1649811" cy="12328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/>
          <a:srcRect l="15938" t="32576" r="21008" b="33291"/>
          <a:stretch>
            <a:fillRect/>
          </a:stretch>
        </p:blipFill>
        <p:spPr bwMode="auto">
          <a:xfrm>
            <a:off x="1043608" y="1124744"/>
            <a:ext cx="1656184" cy="129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9"/>
          <p:cNvPicPr>
            <a:picLocks noChangeAspect="1" noChangeArrowheads="1"/>
          </p:cNvPicPr>
          <p:nvPr/>
        </p:nvPicPr>
        <p:blipFill>
          <a:blip r:embed="rId8" cstate="print"/>
          <a:srcRect l="83598" t="5394" r="11973" b="9087"/>
          <a:stretch>
            <a:fillRect/>
          </a:stretch>
        </p:blipFill>
        <p:spPr bwMode="auto">
          <a:xfrm>
            <a:off x="7524328" y="1052736"/>
            <a:ext cx="504056" cy="3240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>
            <a:off x="8028384" y="1115452"/>
            <a:ext cx="5934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/>
              <a:t>0.70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8028384" y="2915652"/>
            <a:ext cx="5934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/>
              <a:t>0.60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8028384" y="3923764"/>
            <a:ext cx="5934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/>
              <a:t>0.54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8028384" y="2123564"/>
            <a:ext cx="5934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/>
              <a:t>0.64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3851920" y="2606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2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7596336" y="548680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(J≠0)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1187624" y="692696"/>
            <a:ext cx="3913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inimum Norm, Sessions 1-9, t=0.105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533400" y="6211669"/>
            <a:ext cx="8077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osterior probability maps of the minimum norm estimates over the 9 scanning sessions at t=0.105s. The colour scale shows the probability that J=0.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63</Words>
  <Application>Microsoft Office PowerPoint</Application>
  <PresentationFormat>On-screen Show (4:3)</PresentationFormat>
  <Paragraphs>1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areth Barnes</dc:creator>
  <cp:lastModifiedBy>ltroeb</cp:lastModifiedBy>
  <cp:revision>13</cp:revision>
  <dcterms:created xsi:type="dcterms:W3CDTF">2006-08-16T00:00:00Z</dcterms:created>
  <dcterms:modified xsi:type="dcterms:W3CDTF">2013-08-15T13:12:15Z</dcterms:modified>
</cp:coreProperties>
</file>